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534235" y="146422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735220-EE7B-5E13-CC53-B58E52BCBDF8}"/>
              </a:ext>
            </a:extLst>
          </p:cNvPr>
          <p:cNvSpPr txBox="1"/>
          <p:nvPr/>
        </p:nvSpPr>
        <p:spPr>
          <a:xfrm>
            <a:off x="3790487" y="146422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5055654" y="1469818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&lt;10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6158463" y="1464221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&gt;1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5251804" y="1089293"/>
            <a:ext cx="1813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ractionated CM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/>
          <p:nvPr/>
        </p:nvCxnSpPr>
        <p:spPr>
          <a:xfrm>
            <a:off x="5167098" y="1464221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C838832D-F2B7-3B50-174B-1506E25834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18928" y="3072486"/>
            <a:ext cx="3600000" cy="1155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A5A95F9-E4A7-D0AB-8440-13CCAE471B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2262357" y="3056054"/>
            <a:ext cx="3600000" cy="1155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8D139C7-E9A0-C145-6D5F-D327BD01CA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4296000" y="2472486"/>
            <a:ext cx="3600000" cy="235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2129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534235" y="146422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735220-EE7B-5E13-CC53-B58E52BCBDF8}"/>
              </a:ext>
            </a:extLst>
          </p:cNvPr>
          <p:cNvSpPr txBox="1"/>
          <p:nvPr/>
        </p:nvSpPr>
        <p:spPr>
          <a:xfrm>
            <a:off x="3790487" y="146422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5055654" y="1469818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&lt;10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6158463" y="1464221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&gt;1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5251804" y="1089293"/>
            <a:ext cx="1813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ractionated CM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/>
          <p:nvPr/>
        </p:nvCxnSpPr>
        <p:spPr>
          <a:xfrm>
            <a:off x="5167098" y="1464221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3DEE7096-C4B2-1B85-D170-50E1EBF229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78369" y="3029719"/>
            <a:ext cx="3600000" cy="120766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9503FB5-1697-36C5-6069-24A193654F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402680" y="3029719"/>
            <a:ext cx="3600000" cy="120766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BD3A1C6-5E95-93D4-D33D-9F66FE91C2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4365328" y="2391382"/>
            <a:ext cx="3600000" cy="2484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21428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534235" y="146422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735220-EE7B-5E13-CC53-B58E52BCBDF8}"/>
              </a:ext>
            </a:extLst>
          </p:cNvPr>
          <p:cNvSpPr txBox="1"/>
          <p:nvPr/>
        </p:nvSpPr>
        <p:spPr>
          <a:xfrm>
            <a:off x="3790487" y="146422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5055654" y="1469818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&lt;10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6158463" y="1464221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&gt;1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5251804" y="1089293"/>
            <a:ext cx="1813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ractionated CM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/>
          <p:nvPr/>
        </p:nvCxnSpPr>
        <p:spPr>
          <a:xfrm>
            <a:off x="5167098" y="1464221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1DF756F0-2788-4619-F073-F9850D58D2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18927" y="3016198"/>
            <a:ext cx="3600000" cy="123471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86D812C-73BA-A894-6C5C-27AD99F86A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357732" y="3031075"/>
            <a:ext cx="3600000" cy="120495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CA5F3A1-114B-D3D8-45D4-60B3F33AAA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4314926" y="2432350"/>
            <a:ext cx="3600000" cy="2424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1370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1</TotalTime>
  <Words>33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18</cp:revision>
  <dcterms:created xsi:type="dcterms:W3CDTF">2024-06-06T16:34:22Z</dcterms:created>
  <dcterms:modified xsi:type="dcterms:W3CDTF">2024-06-17T13:54:44Z</dcterms:modified>
</cp:coreProperties>
</file>